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3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3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613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093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628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766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726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669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812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699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932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909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037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E567BA25-24EE-B4ED-EE5B-1D7867C9C7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3780" y="2854981"/>
            <a:ext cx="2189988" cy="139217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6E41978-890D-EF32-5142-BAEEC255D7D9}"/>
              </a:ext>
            </a:extLst>
          </p:cNvPr>
          <p:cNvSpPr txBox="1"/>
          <p:nvPr/>
        </p:nvSpPr>
        <p:spPr>
          <a:xfrm>
            <a:off x="900870" y="4808556"/>
            <a:ext cx="5363570" cy="26314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Figure S5. The </a:t>
            </a:r>
            <a:r>
              <a:rPr lang="en-US" sz="1100" b="1" i="1" dirty="0"/>
              <a:t>SMC1A</a:t>
            </a:r>
            <a:r>
              <a:rPr lang="en-US" sz="1100" b="1" dirty="0"/>
              <a:t>-DEE mutation escapes from skewed XCI in blood of the heterozygous patient 3</a:t>
            </a:r>
            <a:endParaRPr lang="en-US" sz="1100" dirty="0"/>
          </a:p>
          <a:p>
            <a:r>
              <a:rPr lang="en-US" sz="1100" dirty="0"/>
              <a:t>Snap shots of Sanger sequencing results for the mutation-containing PCR products with genomic DNA (gDNA) or with cDNA from blood of the patient 3 which carries a G to A mutation at cDNA position of 1487. cDNA obtained by reverse transcription of patient blood RNA was subject to PCR using cDNA-specific primers to avoid any potential gDNA contamination. Since patient 3 has a completely skewed XCI in blood, the presence of double peaks (G/A; dotted box) in the cDNA-derived PCR product reveals expression of both wild-type and mutated alleles. In addition, the G/A height ratio is increased by ~4-fold from the cDNA-derived PCR product compared to that from the gDNA-derived PCR product, suggesting most of SMC1A expression is from the wild-type allele. Given that the allele on the active X chromosome (</a:t>
            </a:r>
            <a:r>
              <a:rPr lang="en-US" sz="1100" dirty="0" err="1"/>
              <a:t>Xa</a:t>
            </a:r>
            <a:r>
              <a:rPr lang="en-US" sz="1100" dirty="0"/>
              <a:t>) is expressed at a higher level than that on the inactive X chromosome (Xi), we can infer that the mutated allele is on the Xi and the expression level of the mutation (i.e., the escape level) is about 25% of that of the wild type allele on the active X chromosome.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C0C0F09-B0CC-C56F-BC2C-13A56B8EE3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3780" y="1309424"/>
            <a:ext cx="2186559" cy="143903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BC3B3C3-B58F-FD23-D72D-47E3B50B4F70}"/>
              </a:ext>
            </a:extLst>
          </p:cNvPr>
          <p:cNvSpPr txBox="1"/>
          <p:nvPr/>
        </p:nvSpPr>
        <p:spPr>
          <a:xfrm>
            <a:off x="1256860" y="1825327"/>
            <a:ext cx="129731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DNA-specific PCR product</a:t>
            </a:r>
          </a:p>
          <a:p>
            <a:endParaRPr lang="en-US" sz="1400" dirty="0"/>
          </a:p>
          <a:p>
            <a:endParaRPr lang="en-US" sz="1400" dirty="0"/>
          </a:p>
          <a:p>
            <a:endParaRPr lang="en-US" sz="1400" dirty="0"/>
          </a:p>
          <a:p>
            <a:endParaRPr lang="en-US" sz="1400" dirty="0"/>
          </a:p>
          <a:p>
            <a:r>
              <a:rPr lang="en-US" sz="1400" dirty="0"/>
              <a:t>  </a:t>
            </a:r>
          </a:p>
          <a:p>
            <a:r>
              <a:rPr lang="en-US" sz="1400" dirty="0"/>
              <a:t>cDNA-specific PCR product   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76DB6E7-CFA3-0A2C-57AE-6C711D3727B5}"/>
              </a:ext>
            </a:extLst>
          </p:cNvPr>
          <p:cNvSpPr txBox="1"/>
          <p:nvPr/>
        </p:nvSpPr>
        <p:spPr>
          <a:xfrm>
            <a:off x="3442731" y="2688995"/>
            <a:ext cx="43633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/A</a:t>
            </a:r>
          </a:p>
          <a:p>
            <a:r>
              <a:rPr lang="en-US" sz="1100" dirty="0"/>
              <a:t>0.70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AE4D25C-1A4C-EFAB-5F28-0B3022CF4860}"/>
              </a:ext>
            </a:extLst>
          </p:cNvPr>
          <p:cNvSpPr/>
          <p:nvPr/>
        </p:nvSpPr>
        <p:spPr>
          <a:xfrm>
            <a:off x="3556000" y="1268887"/>
            <a:ext cx="232229" cy="3363437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1A176C4-C9A9-4D40-B2BE-8420C20805FE}"/>
              </a:ext>
            </a:extLst>
          </p:cNvPr>
          <p:cNvSpPr txBox="1"/>
          <p:nvPr/>
        </p:nvSpPr>
        <p:spPr>
          <a:xfrm>
            <a:off x="2539335" y="877756"/>
            <a:ext cx="2086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atient 3 (c.1487G&gt;A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1C2B751-0CC3-7DDA-67B9-BC57B83B9E21}"/>
              </a:ext>
            </a:extLst>
          </p:cNvPr>
          <p:cNvSpPr txBox="1"/>
          <p:nvPr/>
        </p:nvSpPr>
        <p:spPr>
          <a:xfrm>
            <a:off x="3447890" y="4224296"/>
            <a:ext cx="43633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/A</a:t>
            </a:r>
          </a:p>
          <a:p>
            <a:r>
              <a:rPr lang="en-US" sz="1100" dirty="0"/>
              <a:t>2.96</a:t>
            </a:r>
          </a:p>
        </p:txBody>
      </p:sp>
    </p:spTree>
    <p:extLst>
      <p:ext uri="{BB962C8B-B14F-4D97-AF65-F5344CB8AC3E}">
        <p14:creationId xmlns:p14="http://schemas.microsoft.com/office/powerpoint/2010/main" val="3348648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46da4d3-ba20-4986-879c-49e262eff745}" enabled="1" method="Standard" siteId="{9f693e63-5e9e-4ced-98a4-8ab28f9d0c2d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63</TotalTime>
  <Words>252</Words>
  <Application>Microsoft Office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nxian Deng</dc:creator>
  <cp:lastModifiedBy>Bozarth, Xiuhua</cp:lastModifiedBy>
  <cp:revision>9</cp:revision>
  <dcterms:created xsi:type="dcterms:W3CDTF">2023-01-12T22:53:53Z</dcterms:created>
  <dcterms:modified xsi:type="dcterms:W3CDTF">2023-01-31T23:01:03Z</dcterms:modified>
</cp:coreProperties>
</file>